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87CC94-CC31-4FA5-8BE5-E3FBAB5949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1D2638D-25AD-4A1A-90CC-4DF67FDEE2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CC3469-414C-47A1-9BC6-D749CB46F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87F65CD-C299-416B-A2FB-9BE76A3A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C61F31-D661-4483-AD1D-A17EEFE4A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88924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8C55BB-2F42-4965-96AE-A553F770A9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2412399-388F-4D08-8B5D-B8E604762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2A73EC3-FB45-4E0F-B9D0-B27CEAB1F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F54E02-4AA1-4757-9207-AFE2BA47E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5150FDC-05FE-48BB-A220-FB0991EEF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74821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2C8B7EF-DC2D-4E87-A615-2CE728FC6D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8774010-3F4F-4F44-95CA-5D46CE8A66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4FAA89-04C3-427E-880B-2660C381D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769D7A6-AAAF-4258-8BBF-C277C2F96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65D136B-B48B-4947-9E17-099A774F8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22257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B397D2-5AAB-483B-A372-F50F1BF208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6781DEB-D215-4C54-A2AF-5889C28824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F9DB2CA-4C1F-455E-A381-6FEFBB5F9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F920F94-DD3C-4074-B8C1-90C065342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4C5243-639D-4A64-9186-3ED3BC901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1782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8AC398-BEDD-44BF-A90D-1436AFA9C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9DBB7C9-053C-428F-9D6C-70A672ABEC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7E27D0-60BC-402A-9ACF-94FA9068F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A4F5CD-A877-400F-A4BE-33D24D4EE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08A44AB-CC9D-4079-A8D9-905A23107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81178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9621DD-750E-4D57-BBFA-163D4CF8B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F7F552F-1F7B-40FF-88A4-B860AF07F0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578A0ED-785E-4510-A490-409B551BB4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A3BCB34-4AD0-465F-ABCC-AC71AFEC5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54B0F41-A67E-49D3-A59F-A2285AA1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01C47BB-E181-468A-BD2F-E89DBE79C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3663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9ACEE8-2390-4E76-B4C2-551FA0F1AD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668B88B-B27A-425D-AE7C-0ADDE0CE70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911CBE4-060C-453A-A858-8AC62E0D85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059D1D5-624F-4C99-93F4-20C7E52BC2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1633BD6-4401-418C-9C25-BE0ACED28F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75030C62-638F-4281-A7A0-135A74A6F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048F052-03C8-40C3-8838-1D1981F29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14E5DB4-CE12-480C-B2B9-E95471C60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7427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5A1AF0-BA16-4DD1-9C1C-72E5246434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604A048-40DD-40C4-8692-DFF283857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96F6750-375F-4127-94FD-2154AADBC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C7876FC-7A27-4C6F-8D39-69FBAB097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93090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C41A74F-943E-47A5-881A-7D1110EB7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E2CCA20-23D3-40AE-83A7-8421B09AB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2B46119-E2D2-4591-B2D6-E3F82FBCA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7429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F862CB-76F8-4D1D-B7FD-6E53F5E3A8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7DFE678-AA96-4B9F-9EB1-6081D221CE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FEFB217-2D78-494D-B8BD-D2A9D42735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BA20F1-9806-4293-A289-860CA8398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5538547-9331-47AA-8081-8E7B49895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5664E8A-6EC1-4933-BA2D-0CE07B4CE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40527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F75167-5928-42C0-8B43-975D3E6B1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9263D1E-134F-4A62-BDE0-AFC0EB7BB9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1619512-05D9-4E99-9F7B-11A0F47C42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79C877B-FE38-4AE9-9210-B368C5ED6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C67CE4E-61CA-468B-BCC1-0548025A1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070E2CF-97E7-43CB-8C96-190101E43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09343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DC1F003-53AD-4915-8B8D-F7033B4937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DE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0449A1D-BFE2-4CFC-A49A-A1898FB7A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146537-F14C-47F5-9A57-E1C491A291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1C8F5-9293-468F-A19C-6EFC112B872D}" type="datetimeFigureOut">
              <a:rPr lang="en-DE" smtClean="0"/>
              <a:t>29/08/2024</a:t>
            </a:fld>
            <a:endParaRPr lang="en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558A83-7810-4293-B448-7DA59BD96A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744FC48-8781-4787-B1F0-4D5C742DC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95135-92B0-468A-8F51-7AC223939787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09104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9">
            <a:extLst>
              <a:ext uri="{FF2B5EF4-FFF2-40B4-BE49-F238E27FC236}">
                <a16:creationId xmlns:a16="http://schemas.microsoft.com/office/drawing/2014/main" id="{6507D9E6-655C-4680-B923-F7CE04299D9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4" t="8296" r="13462" b="30567"/>
          <a:stretch/>
        </p:blipFill>
        <p:spPr>
          <a:xfrm>
            <a:off x="1388533" y="1896532"/>
            <a:ext cx="9078851" cy="3615267"/>
          </a:xfrm>
          <a:prstGeom prst="rect">
            <a:avLst/>
          </a:prstGeom>
          <a:noFill/>
          <a:ln w="12700">
            <a:noFill/>
          </a:ln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FD1BD46D-12BC-4DB6-A25F-AB8456F47D34}"/>
              </a:ext>
            </a:extLst>
          </p:cNvPr>
          <p:cNvSpPr txBox="1"/>
          <p:nvPr/>
        </p:nvSpPr>
        <p:spPr>
          <a:xfrm>
            <a:off x="59267" y="76200"/>
            <a:ext cx="8132676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ource Data for Figure S2A: PU.1 Western Blot</a:t>
            </a:r>
            <a:br>
              <a:rPr lang="en-GB" b="1" dirty="0"/>
            </a:br>
            <a:br>
              <a:rPr lang="en-GB" b="1" dirty="0"/>
            </a:br>
            <a:r>
              <a:rPr lang="en-GB" sz="1400" dirty="0"/>
              <a:t>For the paper we used the lanes with “B22” (which we named in </a:t>
            </a:r>
            <a:r>
              <a:rPr lang="en-GB" sz="1400"/>
              <a:t>the paper “URE-AML”), </a:t>
            </a:r>
            <a:r>
              <a:rPr lang="en-GB" sz="1400" dirty="0" err="1"/>
              <a:t>HoxWT</a:t>
            </a:r>
            <a:r>
              <a:rPr lang="en-GB" sz="1400" dirty="0"/>
              <a:t> and </a:t>
            </a:r>
            <a:r>
              <a:rPr lang="en-GB" sz="1400" dirty="0" err="1"/>
              <a:t>HoxURE</a:t>
            </a:r>
            <a:r>
              <a:rPr lang="en-GB" sz="1400" dirty="0"/>
              <a:t>).</a:t>
            </a:r>
            <a:br>
              <a:rPr lang="en-GB" sz="1400" dirty="0"/>
            </a:br>
            <a:r>
              <a:rPr lang="en-GB" sz="1400" dirty="0"/>
              <a:t>All other lanes except the marker were not considered.</a:t>
            </a:r>
            <a:endParaRPr lang="en-DE" sz="1400" dirty="0"/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3D889578-1164-4663-8A4B-36C84E539C10}"/>
              </a:ext>
            </a:extLst>
          </p:cNvPr>
          <p:cNvCxnSpPr/>
          <p:nvPr/>
        </p:nvCxnSpPr>
        <p:spPr>
          <a:xfrm>
            <a:off x="5334000" y="1820333"/>
            <a:ext cx="0" cy="745067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Gerade Verbindung mit Pfeil 7">
            <a:extLst>
              <a:ext uri="{FF2B5EF4-FFF2-40B4-BE49-F238E27FC236}">
                <a16:creationId xmlns:a16="http://schemas.microsoft.com/office/drawing/2014/main" id="{52A546E8-571F-4D51-AB31-65BDCD96CCFB}"/>
              </a:ext>
            </a:extLst>
          </p:cNvPr>
          <p:cNvCxnSpPr/>
          <p:nvPr/>
        </p:nvCxnSpPr>
        <p:spPr>
          <a:xfrm>
            <a:off x="6231467" y="1820333"/>
            <a:ext cx="0" cy="745067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Gerade Verbindung mit Pfeil 8">
            <a:extLst>
              <a:ext uri="{FF2B5EF4-FFF2-40B4-BE49-F238E27FC236}">
                <a16:creationId xmlns:a16="http://schemas.microsoft.com/office/drawing/2014/main" id="{5AD7ED88-1A51-4FE9-8028-EB59A3E23369}"/>
              </a:ext>
            </a:extLst>
          </p:cNvPr>
          <p:cNvCxnSpPr/>
          <p:nvPr/>
        </p:nvCxnSpPr>
        <p:spPr>
          <a:xfrm>
            <a:off x="6705600" y="1820333"/>
            <a:ext cx="0" cy="745067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5263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exander Bender</dc:creator>
  <cp:lastModifiedBy>Alexander Bender</cp:lastModifiedBy>
  <cp:revision>2</cp:revision>
  <dcterms:created xsi:type="dcterms:W3CDTF">2024-08-29T19:57:56Z</dcterms:created>
  <dcterms:modified xsi:type="dcterms:W3CDTF">2024-08-29T19:59:23Z</dcterms:modified>
</cp:coreProperties>
</file>